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9" r:id="rId4"/>
    <p:sldId id="258" r:id="rId5"/>
    <p:sldId id="260" r:id="rId6"/>
  </p:sldIdLst>
  <p:sldSz cx="6858000" cy="9903460" type="A4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170"/>
        <p:guide pos="2129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63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681" y="383229"/>
            <a:ext cx="6467987" cy="3233994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51840" y="113699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51840" y="188371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51840" y="3127643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51840" y="746756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51840" y="586475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51840" y="450372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51840" y="1433375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1840" y="350317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66140" y="2280900"/>
            <a:ext cx="6256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51840" y="327288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788654" y="1167760"/>
            <a:ext cx="639916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-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3788654" y="1765749"/>
            <a:ext cx="10877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eaved caspase-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788654" y="2749824"/>
            <a:ext cx="10877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788654" y="2156125"/>
            <a:ext cx="10877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788654" y="2399788"/>
            <a:ext cx="10877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672590" y="33147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156460" y="33147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670810" y="208280"/>
            <a:ext cx="6781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NC inhitbit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172460" y="208280"/>
            <a:ext cx="9194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miR-145 inhitbit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0" y="508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2D</a:t>
            </a:r>
            <a:endParaRPr lang="en-US" altLang="zh-CN" sz="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片包含 游戏机&#10;&#10;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555" y="312967"/>
            <a:ext cx="6075639" cy="334270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96514" y="104033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96514" y="1627080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6514" y="283292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6514" y="74913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96514" y="596475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6514" y="460373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96514" y="126816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96514" y="360318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10815" y="1993797"/>
            <a:ext cx="6256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96514" y="3214327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631221" y="1519162"/>
            <a:ext cx="61912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631221" y="1170639"/>
            <a:ext cx="51435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631221" y="758630"/>
            <a:ext cx="569242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631221" y="930663"/>
            <a:ext cx="7764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X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631221" y="1049053"/>
            <a:ext cx="7764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0" y="508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3C</a:t>
            </a:r>
            <a:endParaRPr lang="en-US" altLang="zh-CN" sz="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704340" y="33147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188210" y="33147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702560" y="208280"/>
            <a:ext cx="6781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NC inhitbit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204210" y="208280"/>
            <a:ext cx="9194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miR-145 inhitbit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60" y="758060"/>
            <a:ext cx="4954891" cy="3354413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35570" y="1466950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35570" y="221366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35570" y="345760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35570" y="1076715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35570" y="916433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35570" y="78033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35570" y="1763334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35570" y="680276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49870" y="2610858"/>
            <a:ext cx="6256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35570" y="3602847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679074" y="1466950"/>
            <a:ext cx="639916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-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661122" y="3128184"/>
            <a:ext cx="8454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BARAPL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418590" y="544195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977390" y="544195"/>
            <a:ext cx="96964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amethaso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0" y="508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4D</a:t>
            </a:r>
            <a:endParaRPr lang="en-US" altLang="zh-CN" sz="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379" y="297104"/>
            <a:ext cx="5765838" cy="33671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96514" y="104033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96514" y="1627080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6514" y="283292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6514" y="749139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96514" y="596475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6514" y="460373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96514" y="1268161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96514" y="360318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10815" y="1993797"/>
            <a:ext cx="6256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96514" y="3214327"/>
            <a:ext cx="63991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94096" y="1526780"/>
            <a:ext cx="61912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494096" y="1170639"/>
            <a:ext cx="51435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494096" y="758630"/>
            <a:ext cx="569242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494096" y="930663"/>
            <a:ext cx="7764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X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494096" y="1049053"/>
            <a:ext cx="7764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0" y="508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5F</a:t>
            </a:r>
            <a:endParaRPr lang="en-US" altLang="zh-CN" sz="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469390" y="28321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921510" y="283210"/>
            <a:ext cx="6781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277110" y="36830"/>
            <a:ext cx="80518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NC inhitbitor+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16860" y="36830"/>
            <a:ext cx="91948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miR-145 inhitbitor+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496310" y="36830"/>
            <a:ext cx="99504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X+miR-145 inhitbitor+</a:t>
            </a:r>
            <a:endParaRPr lang="en-US" altLang="zh-CN" sz="800" dirty="0" err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h-GABARAPL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COMMONDATA" val="eyJoZGlkIjoiMmExZGUyZDNmY2ZkMzg2OWJkNjI2NmYyYjgxZTNhOGQifQ=="/>
  <p:tag name="KSO_WPP_MARK_KEY" val="fd04074e-face-451b-9021-e351de3811c5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7</Words>
  <Application>WPS 演示</Application>
  <PresentationFormat>宽屏</PresentationFormat>
  <Paragraphs>155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Author</cp:lastModifiedBy>
  <cp:revision>152</cp:revision>
  <dcterms:created xsi:type="dcterms:W3CDTF">2019-06-19T02:08:00Z</dcterms:created>
  <dcterms:modified xsi:type="dcterms:W3CDTF">2022-10-20T01:50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02</vt:lpwstr>
  </property>
  <property fmtid="{D5CDD505-2E9C-101B-9397-08002B2CF9AE}" pid="3" name="ICV">
    <vt:lpwstr>A88FF4CF59884D768BCC06EEA97641B6</vt:lpwstr>
  </property>
</Properties>
</file>